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58" r:id="rId2"/>
    <p:sldId id="260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6491"/>
    <p:restoredTop sz="85548"/>
  </p:normalViewPr>
  <p:slideViewPr>
    <p:cSldViewPr snapToGrid="0">
      <p:cViewPr varScale="1">
        <p:scale>
          <a:sx n="72" d="100"/>
          <a:sy n="72" d="100"/>
        </p:scale>
        <p:origin x="1574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51E4355-A4C9-0B4F-B454-9C57120A7863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CDD7B4C-E4B8-3B42-BA4F-CF09711ED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49923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CDD7B4C-E4B8-3B42-BA4F-CF09711ED5C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906985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CDD7B4C-E4B8-3B42-BA4F-CF09711ED5C9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62669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F295A6-18F6-DACA-C423-CC3E30AACEE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B81AF63-6DA1-0A73-1ED3-54C963818DB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CEDDEF-65F9-FF60-F6EF-345F97B101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08D74-A5B6-E547-BDE8-46C77ED4B21E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7560AE-1663-8A08-8A64-95EED11E39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D2F2F5-796E-55B7-8F52-3017274908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B3381-2CE3-204C-A9FC-8EBFF3A877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65925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0C4913-F813-D2A6-3985-72A9A09432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3917FCD-5989-975A-96EC-6BF72FCAC6A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D65E31-6991-84D5-0528-5F60C60AF5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08D74-A5B6-E547-BDE8-46C77ED4B21E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89CC46-B10D-9492-FCFC-3C7D49D3FE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BD7F24-B6A7-C236-D7C7-A9BA79928D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B3381-2CE3-204C-A9FC-8EBFF3A877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07649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5EA977D-F652-B335-CB31-B9A68603D94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78F46A1-E259-CD04-59B0-D21B833F8B1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5B305F-4F76-AEFA-DF93-DE7805F05E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08D74-A5B6-E547-BDE8-46C77ED4B21E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F6FCB5-E484-30C7-076C-5A9415BBE0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3C5988-AC18-0FDF-E6AB-C0BFB8EA04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B3381-2CE3-204C-A9FC-8EBFF3A877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51575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DF38D2-D417-9C10-AADD-3E9DD28690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38EE396-9BD8-942C-18B5-64083C7FFB7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924FCB-746C-1CB3-256C-0B509CCCCF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08D74-A5B6-E547-BDE8-46C77ED4B21E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678446-1DC2-106E-F391-69C4082313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456492-393C-8AC7-446F-A96FB04AF8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B3381-2CE3-204C-A9FC-8EBFF3A877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82200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C5EC22-42B8-E90C-74D9-FDA54A02DA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95B1EAF-50CD-EDA0-0645-D78240CA6F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4E764E-4038-6CAA-A1D6-E1FBC4A5C7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08D74-A5B6-E547-BDE8-46C77ED4B21E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51E9AC-AEF9-FAF1-39CC-4BCB4E2E7A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D2CB0B-EF94-6EA1-D68E-45B9905E60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B3381-2CE3-204C-A9FC-8EBFF3A877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16597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CD321A-B384-BF34-645B-2593222BA4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67A6EC-0880-D247-689F-9E5C8B8FEFD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D96CFF2-51FA-3FB6-6F4D-A0BF3AA24E5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4BA5C6-42B1-A7C3-8D69-68FF26D988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08D74-A5B6-E547-BDE8-46C77ED4B21E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CF75A2A-A605-655A-9A91-4DCDBEFFC0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17AB998-D9FD-6439-2AC8-6AA03F6A76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B3381-2CE3-204C-A9FC-8EBFF3A877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19777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817959-70E0-5285-FE5D-D79E464F30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1D41F1-C1E9-44BB-7575-99263D3604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C83B68B-F5DE-F7FA-33AF-46A364CF0D7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8E1D764-BFE8-D197-67F9-98D2BEE9BFA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184F294-B509-EC92-66AA-5BE0CEF4C94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EAF5E04-C2D3-C9F2-B86E-0FB202E56A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08D74-A5B6-E547-BDE8-46C77ED4B21E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DE21AE4-35CF-D4E5-C3A5-CB3A4A5764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942B031-FAEB-5132-17CD-3D4E2704A9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B3381-2CE3-204C-A9FC-8EBFF3A877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03831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6383D9-E5B2-8380-10E9-FDC3D113E0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526E24D-C116-1735-DE08-1B0CFF35F1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08D74-A5B6-E547-BDE8-46C77ED4B21E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BD85F00-A5F0-45E5-306F-AAEA9624A4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22A5BCA-21E4-1878-B1B1-B5856857AA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B3381-2CE3-204C-A9FC-8EBFF3A877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38615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22A15BE-B278-3781-D9EB-8614E41935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08D74-A5B6-E547-BDE8-46C77ED4B21E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ED8B6F9-54C4-84B7-6D75-EE6D17B156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C4C7093-EE80-97E4-BC5E-B82B15F1CB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B3381-2CE3-204C-A9FC-8EBFF3A877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90637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976CDA-3D9A-D972-3C58-862017EBAC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1491F92-3F33-EEA7-1AFC-FF9C9CA69A1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F6B85D2-20CB-1471-7CF9-3F74DFF309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058D8CA-8CBE-5698-8180-A99D040526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08D74-A5B6-E547-BDE8-46C77ED4B21E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A7B1829-225A-1E2C-8A60-BDA333A6E5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E134478-9B9C-06F5-0D84-746C2A4E32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B3381-2CE3-204C-A9FC-8EBFF3A877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57008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F4EED8-D122-DDC1-D9D8-93CEE81E2B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AE30853-6194-2875-3397-3EFFC0D20B1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6B87451-EB4A-1CD2-9918-4F01CFBDCE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B23DBFF-4F81-9414-54EB-4E231FFEBC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08D74-A5B6-E547-BDE8-46C77ED4B21E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42B8014-D463-17B1-2A72-97C4348179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A4C1F18-4C77-8170-654D-5ACA365559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B3381-2CE3-204C-A9FC-8EBFF3A877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18481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B030DA4-7777-C71E-776C-0F6FBC4FF2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D333CF8-9EB7-1ACE-1745-9376769383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01AE06-9BED-FD2A-64B8-CC5D58304AA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EF08D74-A5B6-E547-BDE8-46C77ED4B21E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5C3A0A-4F33-2B44-6876-4F313BE0153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1F79EF-2684-399F-5F90-01D1C67186C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ADB3381-2CE3-204C-A9FC-8EBFF3A877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4703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D73D2269-AADC-B9CA-9DB8-7813CB854685}"/>
              </a:ext>
            </a:extLst>
          </p:cNvPr>
          <p:cNvSpPr txBox="1"/>
          <p:nvPr/>
        </p:nvSpPr>
        <p:spPr>
          <a:xfrm>
            <a:off x="169600" y="592410"/>
            <a:ext cx="9316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Treatment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68DB935-C371-A21A-1A66-3EB0E4303480}"/>
              </a:ext>
            </a:extLst>
          </p:cNvPr>
          <p:cNvSpPr txBox="1"/>
          <p:nvPr/>
        </p:nvSpPr>
        <p:spPr>
          <a:xfrm>
            <a:off x="3553925" y="592410"/>
            <a:ext cx="762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Patient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D6C835E-497D-68B3-8F01-869B678607B1}"/>
              </a:ext>
            </a:extLst>
          </p:cNvPr>
          <p:cNvSpPr txBox="1"/>
          <p:nvPr/>
        </p:nvSpPr>
        <p:spPr>
          <a:xfrm>
            <a:off x="2922702" y="592410"/>
            <a:ext cx="4796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Lin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B1AEB05-4149-7920-D840-F617DC1DE2FE}"/>
              </a:ext>
            </a:extLst>
          </p:cNvPr>
          <p:cNvSpPr txBox="1"/>
          <p:nvPr/>
        </p:nvSpPr>
        <p:spPr>
          <a:xfrm>
            <a:off x="6140445" y="592410"/>
            <a:ext cx="13090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Efficacy Result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5CBADE0-A008-4CD6-848E-4BB124E82A43}"/>
              </a:ext>
            </a:extLst>
          </p:cNvPr>
          <p:cNvSpPr txBox="1"/>
          <p:nvPr/>
        </p:nvSpPr>
        <p:spPr>
          <a:xfrm>
            <a:off x="10626566" y="592410"/>
            <a:ext cx="1566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Trial No./Referenc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E8EE266-5039-CA76-D402-B5DEA9C1784F}"/>
              </a:ext>
            </a:extLst>
          </p:cNvPr>
          <p:cNvSpPr txBox="1"/>
          <p:nvPr/>
        </p:nvSpPr>
        <p:spPr>
          <a:xfrm>
            <a:off x="169600" y="816651"/>
            <a:ext cx="13452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Milademetan</a:t>
            </a:r>
            <a:r>
              <a:rPr lang="en-US" sz="1200" dirty="0"/>
              <a:t> (MDM2 inhibitor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E40C5E8-67E9-8D6B-CB6E-DA7E82B3B1DE}"/>
              </a:ext>
            </a:extLst>
          </p:cNvPr>
          <p:cNvSpPr txBox="1"/>
          <p:nvPr/>
        </p:nvSpPr>
        <p:spPr>
          <a:xfrm>
            <a:off x="2922702" y="816651"/>
            <a:ext cx="4424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--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420BA97-638E-D2E1-091C-FFF85170322A}"/>
              </a:ext>
            </a:extLst>
          </p:cNvPr>
          <p:cNvSpPr txBox="1"/>
          <p:nvPr/>
        </p:nvSpPr>
        <p:spPr>
          <a:xfrm>
            <a:off x="3553925" y="816651"/>
            <a:ext cx="26428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patients whose tumors have MDM2 gene amplification and p53-wt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FCE1F0F-AC0C-CBE6-C3F0-837F51D19571}"/>
              </a:ext>
            </a:extLst>
          </p:cNvPr>
          <p:cNvSpPr txBox="1"/>
          <p:nvPr/>
        </p:nvSpPr>
        <p:spPr>
          <a:xfrm>
            <a:off x="6140445" y="816651"/>
            <a:ext cx="171931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~29% tumor regression</a:t>
            </a:r>
          </a:p>
          <a:p>
            <a:r>
              <a:rPr lang="en-US" sz="1200" dirty="0"/>
              <a:t>Overall ORR: 19.4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7AD1842-B2D8-0262-0355-4474C179EC73}"/>
              </a:ext>
            </a:extLst>
          </p:cNvPr>
          <p:cNvSpPr txBox="1"/>
          <p:nvPr/>
        </p:nvSpPr>
        <p:spPr>
          <a:xfrm>
            <a:off x="10847556" y="816651"/>
            <a:ext cx="112428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NCT05012397</a:t>
            </a:r>
          </a:p>
          <a:p>
            <a:pPr algn="ctr"/>
            <a:r>
              <a:rPr lang="en-US" sz="1200" dirty="0"/>
              <a:t>[66]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D3409BC-F220-B454-9C76-D124DB286F99}"/>
              </a:ext>
            </a:extLst>
          </p:cNvPr>
          <p:cNvSpPr txBox="1"/>
          <p:nvPr/>
        </p:nvSpPr>
        <p:spPr>
          <a:xfrm>
            <a:off x="2257316" y="592410"/>
            <a:ext cx="6174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Phase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CD41B7E-429A-4C5D-4F11-A6C202648A8C}"/>
              </a:ext>
            </a:extLst>
          </p:cNvPr>
          <p:cNvSpPr txBox="1"/>
          <p:nvPr/>
        </p:nvSpPr>
        <p:spPr>
          <a:xfrm>
            <a:off x="2257316" y="816651"/>
            <a:ext cx="2648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II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7F0CC91-C1D4-322F-0C49-AFB2473A3DCD}"/>
              </a:ext>
            </a:extLst>
          </p:cNvPr>
          <p:cNvSpPr txBox="1"/>
          <p:nvPr/>
        </p:nvSpPr>
        <p:spPr>
          <a:xfrm>
            <a:off x="169601" y="93294"/>
            <a:ext cx="1185387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Supplementary Table S1. Selected Phase II and III clinical trials of targeted therapies showing no clinical efficacy or terminated early, administered as monotherapy or in combination with chemotherapy and/or immunotherapy, in cholangiocarcinoma (CCA).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D06DA06-0701-4801-97E7-46BD58668061}"/>
              </a:ext>
            </a:extLst>
          </p:cNvPr>
          <p:cNvSpPr txBox="1"/>
          <p:nvPr/>
        </p:nvSpPr>
        <p:spPr>
          <a:xfrm>
            <a:off x="169600" y="1381856"/>
            <a:ext cx="18327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GEMOX</a:t>
            </a:r>
          </a:p>
          <a:p>
            <a:r>
              <a:rPr lang="en-US" sz="1200" dirty="0"/>
              <a:t>GEMOX + Panitumumab</a:t>
            </a:r>
          </a:p>
          <a:p>
            <a:r>
              <a:rPr lang="en-US" sz="1200" dirty="0"/>
              <a:t>(EGFR inhibitor)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0930501-A245-357B-8228-D9B8FBF1C09F}"/>
              </a:ext>
            </a:extLst>
          </p:cNvPr>
          <p:cNvSpPr txBox="1"/>
          <p:nvPr/>
        </p:nvSpPr>
        <p:spPr>
          <a:xfrm>
            <a:off x="2922702" y="1381856"/>
            <a:ext cx="4424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st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D29AA61-10DE-3767-7F78-3EEC13F47164}"/>
              </a:ext>
            </a:extLst>
          </p:cNvPr>
          <p:cNvSpPr txBox="1"/>
          <p:nvPr/>
        </p:nvSpPr>
        <p:spPr>
          <a:xfrm>
            <a:off x="3553925" y="1381856"/>
            <a:ext cx="266245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hemotherapy-naïve, advanced unresectable/metastatic CCA, KRAS WT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87519A7-5F08-A735-744A-DFC37A5B0F4D}"/>
              </a:ext>
            </a:extLst>
          </p:cNvPr>
          <p:cNvSpPr txBox="1"/>
          <p:nvPr/>
        </p:nvSpPr>
        <p:spPr>
          <a:xfrm>
            <a:off x="10806680" y="1381856"/>
            <a:ext cx="12060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NCT012389414</a:t>
            </a:r>
          </a:p>
          <a:p>
            <a:pPr algn="ctr"/>
            <a:r>
              <a:rPr lang="en-US" sz="1200" dirty="0"/>
              <a:t>[92]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A5B22F6-36AC-07D0-9212-9E3F2A52A720}"/>
              </a:ext>
            </a:extLst>
          </p:cNvPr>
          <p:cNvSpPr txBox="1"/>
          <p:nvPr/>
        </p:nvSpPr>
        <p:spPr>
          <a:xfrm>
            <a:off x="2257316" y="1381856"/>
            <a:ext cx="2648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II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B8AF056-AE22-858F-1642-D89BFFB21F78}"/>
              </a:ext>
            </a:extLst>
          </p:cNvPr>
          <p:cNvSpPr txBox="1"/>
          <p:nvPr/>
        </p:nvSpPr>
        <p:spPr>
          <a:xfrm>
            <a:off x="6140445" y="1381856"/>
            <a:ext cx="185890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ORR: 39 vs 46 %</a:t>
            </a:r>
          </a:p>
          <a:p>
            <a:r>
              <a:rPr lang="en-US" sz="1200" dirty="0" err="1"/>
              <a:t>mPFS</a:t>
            </a:r>
            <a:r>
              <a:rPr lang="en-US" sz="1200" dirty="0"/>
              <a:t>: 4.4 vs 5.3 </a:t>
            </a:r>
            <a:r>
              <a:rPr lang="en-US" sz="1200" dirty="0" err="1"/>
              <a:t>mo</a:t>
            </a:r>
            <a:endParaRPr lang="en-US" sz="1200" dirty="0"/>
          </a:p>
          <a:p>
            <a:r>
              <a:rPr lang="en-US" sz="1200" dirty="0" err="1"/>
              <a:t>mOS</a:t>
            </a:r>
            <a:r>
              <a:rPr lang="en-US" sz="1200" dirty="0"/>
              <a:t>: 10.2 vs 9.9 </a:t>
            </a:r>
            <a:r>
              <a:rPr lang="en-US" sz="1200" dirty="0" err="1"/>
              <a:t>mo</a:t>
            </a:r>
            <a:r>
              <a:rPr lang="en-US" sz="1200" dirty="0"/>
              <a:t> (NS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2FAA958-9E8C-76B1-2BDB-FF23B016074C}"/>
              </a:ext>
            </a:extLst>
          </p:cNvPr>
          <p:cNvSpPr txBox="1"/>
          <p:nvPr/>
        </p:nvSpPr>
        <p:spPr>
          <a:xfrm>
            <a:off x="169600" y="2165856"/>
            <a:ext cx="183271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Lapatinib monotherapy</a:t>
            </a:r>
          </a:p>
          <a:p>
            <a:r>
              <a:rPr lang="en-US" sz="1200" dirty="0"/>
              <a:t>(EGFR/HER2 inhibitor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3D0570B-D464-B2DA-2225-466015AF6262}"/>
              </a:ext>
            </a:extLst>
          </p:cNvPr>
          <p:cNvSpPr txBox="1"/>
          <p:nvPr/>
        </p:nvSpPr>
        <p:spPr>
          <a:xfrm>
            <a:off x="2922702" y="2165856"/>
            <a:ext cx="4424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st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FB91F12-F911-18EB-2B91-F4A5BFC8E234}"/>
              </a:ext>
            </a:extLst>
          </p:cNvPr>
          <p:cNvSpPr txBox="1"/>
          <p:nvPr/>
        </p:nvSpPr>
        <p:spPr>
          <a:xfrm>
            <a:off x="3553925" y="2165856"/>
            <a:ext cx="26624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dvanced CCA, unselected for HER2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122EFB0-B337-6AB2-772D-18AE5263690B}"/>
              </a:ext>
            </a:extLst>
          </p:cNvPr>
          <p:cNvSpPr txBox="1"/>
          <p:nvPr/>
        </p:nvSpPr>
        <p:spPr>
          <a:xfrm>
            <a:off x="11190727" y="2165856"/>
            <a:ext cx="437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[93]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52187FD-8133-AE70-7D65-15993B09F22B}"/>
              </a:ext>
            </a:extLst>
          </p:cNvPr>
          <p:cNvSpPr txBox="1"/>
          <p:nvPr/>
        </p:nvSpPr>
        <p:spPr>
          <a:xfrm>
            <a:off x="2257316" y="2165856"/>
            <a:ext cx="2648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II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8F3D6A9F-E47A-2E90-5CD9-CD203FDA6B91}"/>
              </a:ext>
            </a:extLst>
          </p:cNvPr>
          <p:cNvSpPr txBox="1"/>
          <p:nvPr/>
        </p:nvSpPr>
        <p:spPr>
          <a:xfrm>
            <a:off x="6140445" y="2165856"/>
            <a:ext cx="112242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ORR: 0 %</a:t>
            </a:r>
          </a:p>
          <a:p>
            <a:r>
              <a:rPr lang="en-US" sz="1200" dirty="0" err="1"/>
              <a:t>mPFS</a:t>
            </a:r>
            <a:r>
              <a:rPr lang="en-US" sz="1200" dirty="0"/>
              <a:t>: 2.6 </a:t>
            </a:r>
            <a:r>
              <a:rPr lang="en-US" sz="1200" dirty="0" err="1"/>
              <a:t>mo</a:t>
            </a:r>
            <a:endParaRPr lang="en-US" sz="1200" dirty="0"/>
          </a:p>
          <a:p>
            <a:r>
              <a:rPr lang="en-US" sz="1200" dirty="0" err="1"/>
              <a:t>mOS</a:t>
            </a:r>
            <a:r>
              <a:rPr lang="en-US" sz="1200" dirty="0"/>
              <a:t>: 5.2 </a:t>
            </a:r>
            <a:r>
              <a:rPr lang="en-US" sz="1200" dirty="0" err="1"/>
              <a:t>mo</a:t>
            </a:r>
            <a:r>
              <a:rPr lang="en-US" sz="1200" dirty="0"/>
              <a:t> 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EE44E993-574B-D9D0-BFFA-42AA1238901E}"/>
              </a:ext>
            </a:extLst>
          </p:cNvPr>
          <p:cNvSpPr txBox="1"/>
          <p:nvPr/>
        </p:nvSpPr>
        <p:spPr>
          <a:xfrm>
            <a:off x="169600" y="2779262"/>
            <a:ext cx="205269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Vandetanib</a:t>
            </a:r>
            <a:endParaRPr lang="en-US" sz="1200" dirty="0"/>
          </a:p>
          <a:p>
            <a:r>
              <a:rPr lang="en-US" sz="1200" dirty="0"/>
              <a:t>(RET/EGFR/VEGFR inhibitor)</a:t>
            </a:r>
          </a:p>
          <a:p>
            <a:r>
              <a:rPr lang="en-US" sz="1200" dirty="0" err="1"/>
              <a:t>Vandetanib+Gemcitabine</a:t>
            </a:r>
            <a:endParaRPr lang="en-US" sz="1200" dirty="0"/>
          </a:p>
          <a:p>
            <a:r>
              <a:rPr lang="en-US" sz="1200" dirty="0"/>
              <a:t>Gemcitabine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C1A7017-D46B-25BA-4D4D-20E135C32A49}"/>
              </a:ext>
            </a:extLst>
          </p:cNvPr>
          <p:cNvSpPr txBox="1"/>
          <p:nvPr/>
        </p:nvSpPr>
        <p:spPr>
          <a:xfrm>
            <a:off x="2922702" y="2779262"/>
            <a:ext cx="4424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st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A25E8E65-5092-DB7A-5002-7D12647A57CB}"/>
              </a:ext>
            </a:extLst>
          </p:cNvPr>
          <p:cNvSpPr txBox="1"/>
          <p:nvPr/>
        </p:nvSpPr>
        <p:spPr>
          <a:xfrm>
            <a:off x="3553925" y="2779262"/>
            <a:ext cx="26624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dvanced CCA, Chemotherapy-naïve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72D54981-EAFC-703D-B113-0E3A0D216A01}"/>
              </a:ext>
            </a:extLst>
          </p:cNvPr>
          <p:cNvSpPr txBox="1"/>
          <p:nvPr/>
        </p:nvSpPr>
        <p:spPr>
          <a:xfrm>
            <a:off x="10847556" y="2779262"/>
            <a:ext cx="112428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NCT00753675</a:t>
            </a:r>
          </a:p>
          <a:p>
            <a:pPr algn="ctr"/>
            <a:r>
              <a:rPr lang="en-US" sz="1200" dirty="0"/>
              <a:t>[95]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964E1FE-B1D7-3177-CBCA-5C3008FD6B40}"/>
              </a:ext>
            </a:extLst>
          </p:cNvPr>
          <p:cNvSpPr txBox="1"/>
          <p:nvPr/>
        </p:nvSpPr>
        <p:spPr>
          <a:xfrm>
            <a:off x="2257316" y="2779262"/>
            <a:ext cx="2648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II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84CB82BD-CA65-80F7-A264-3B95F59AC009}"/>
              </a:ext>
            </a:extLst>
          </p:cNvPr>
          <p:cNvSpPr txBox="1"/>
          <p:nvPr/>
        </p:nvSpPr>
        <p:spPr>
          <a:xfrm>
            <a:off x="6140445" y="2779262"/>
            <a:ext cx="1930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mPFS</a:t>
            </a:r>
            <a:r>
              <a:rPr lang="en-US" sz="1200" dirty="0"/>
              <a:t>: 3.5 vs 3.8 vs 4.9 </a:t>
            </a:r>
            <a:r>
              <a:rPr lang="en-US" sz="1200" dirty="0" err="1"/>
              <a:t>mo</a:t>
            </a:r>
            <a:endParaRPr lang="en-US" sz="1200" dirty="0"/>
          </a:p>
          <a:p>
            <a:r>
              <a:rPr lang="en-US" sz="1200" dirty="0" err="1"/>
              <a:t>mOS</a:t>
            </a:r>
            <a:r>
              <a:rPr lang="en-US" sz="1200" dirty="0"/>
              <a:t>: No difference 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9D239905-92BA-459B-86EE-4DC93AEF6F17}"/>
              </a:ext>
            </a:extLst>
          </p:cNvPr>
          <p:cNvSpPr txBox="1"/>
          <p:nvPr/>
        </p:nvSpPr>
        <p:spPr>
          <a:xfrm>
            <a:off x="169600" y="3545029"/>
            <a:ext cx="214198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Gemcitabine+</a:t>
            </a:r>
          </a:p>
          <a:p>
            <a:r>
              <a:rPr lang="en-US" sz="1200" dirty="0"/>
              <a:t>Capecitabine+</a:t>
            </a:r>
          </a:p>
          <a:p>
            <a:r>
              <a:rPr lang="en-US" sz="1200" dirty="0"/>
              <a:t>Bevacizumab (VEGF inhibitor)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2FB1806C-A10E-6DCC-9388-FF8460BEF365}"/>
              </a:ext>
            </a:extLst>
          </p:cNvPr>
          <p:cNvSpPr txBox="1"/>
          <p:nvPr/>
        </p:nvSpPr>
        <p:spPr>
          <a:xfrm>
            <a:off x="2922702" y="3545029"/>
            <a:ext cx="4424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</a:t>
            </a:r>
            <a:r>
              <a:rPr lang="en-US" sz="1200" baseline="30000" dirty="0"/>
              <a:t>st</a:t>
            </a:r>
            <a:endParaRPr lang="en-US" sz="1200" dirty="0"/>
          </a:p>
          <a:p>
            <a:endParaRPr lang="en-US" sz="1200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F674743C-7089-6DA1-0B28-19202062555B}"/>
              </a:ext>
            </a:extLst>
          </p:cNvPr>
          <p:cNvSpPr txBox="1"/>
          <p:nvPr/>
        </p:nvSpPr>
        <p:spPr>
          <a:xfrm>
            <a:off x="3553925" y="3545029"/>
            <a:ext cx="20345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Inoperable stage III/IV CCA</a:t>
            </a:r>
          </a:p>
          <a:p>
            <a:r>
              <a:rPr lang="en-US" sz="1200" dirty="0"/>
              <a:t>unselected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50B71B28-5228-8E6E-E2B8-0BB9F2322E66}"/>
              </a:ext>
            </a:extLst>
          </p:cNvPr>
          <p:cNvSpPr txBox="1"/>
          <p:nvPr/>
        </p:nvSpPr>
        <p:spPr>
          <a:xfrm>
            <a:off x="6140445" y="3545029"/>
            <a:ext cx="136447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R: 24%; SD: 48%</a:t>
            </a:r>
          </a:p>
          <a:p>
            <a:r>
              <a:rPr lang="en-US" sz="1200" dirty="0" err="1"/>
              <a:t>mPFS</a:t>
            </a:r>
            <a:r>
              <a:rPr lang="en-US" sz="1200" dirty="0"/>
              <a:t>: 8.1 </a:t>
            </a:r>
            <a:r>
              <a:rPr lang="en-US" sz="1200" dirty="0" err="1"/>
              <a:t>mo</a:t>
            </a:r>
            <a:endParaRPr lang="en-US" sz="1200" dirty="0"/>
          </a:p>
          <a:p>
            <a:r>
              <a:rPr lang="en-US" sz="1200" dirty="0" err="1"/>
              <a:t>mOS</a:t>
            </a:r>
            <a:r>
              <a:rPr lang="en-US" sz="1200" dirty="0"/>
              <a:t>: 10.2 </a:t>
            </a:r>
            <a:r>
              <a:rPr lang="en-US" sz="1200" dirty="0" err="1"/>
              <a:t>mo</a:t>
            </a:r>
            <a:endParaRPr lang="en-US" sz="1200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EF94E4D8-972E-19DF-3BC2-35AACF0DC2F0}"/>
              </a:ext>
            </a:extLst>
          </p:cNvPr>
          <p:cNvSpPr txBox="1"/>
          <p:nvPr/>
        </p:nvSpPr>
        <p:spPr>
          <a:xfrm>
            <a:off x="11190727" y="3545029"/>
            <a:ext cx="437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[97]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E92B651B-3A87-50E1-F142-28EF003C7D6B}"/>
              </a:ext>
            </a:extLst>
          </p:cNvPr>
          <p:cNvSpPr txBox="1"/>
          <p:nvPr/>
        </p:nvSpPr>
        <p:spPr>
          <a:xfrm>
            <a:off x="2257316" y="3545029"/>
            <a:ext cx="2648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II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B7DCA18B-0998-E6BF-CE6E-E19E82A97B54}"/>
              </a:ext>
            </a:extLst>
          </p:cNvPr>
          <p:cNvSpPr txBox="1"/>
          <p:nvPr/>
        </p:nvSpPr>
        <p:spPr>
          <a:xfrm>
            <a:off x="169600" y="4761952"/>
            <a:ext cx="149486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Cabozantinib</a:t>
            </a:r>
            <a:endParaRPr lang="en-US" sz="1200" dirty="0"/>
          </a:p>
          <a:p>
            <a:r>
              <a:rPr lang="en-US" sz="1200" dirty="0"/>
              <a:t>(MET, VEGFR2, RET, AXL inhibitor)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5DB44761-BCBB-9BB3-1A41-5235432B3096}"/>
              </a:ext>
            </a:extLst>
          </p:cNvPr>
          <p:cNvSpPr txBox="1"/>
          <p:nvPr/>
        </p:nvSpPr>
        <p:spPr>
          <a:xfrm>
            <a:off x="3553925" y="4761952"/>
            <a:ext cx="237964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dvanced, unresectable, or metastatic CCA, had progressed on one or two systemic therapy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0A1861EF-9D1D-20B3-22B3-BA70B79813B5}"/>
              </a:ext>
            </a:extLst>
          </p:cNvPr>
          <p:cNvSpPr txBox="1"/>
          <p:nvPr/>
        </p:nvSpPr>
        <p:spPr>
          <a:xfrm>
            <a:off x="6140445" y="4761952"/>
            <a:ext cx="11015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mPFS</a:t>
            </a:r>
            <a:r>
              <a:rPr lang="en-US" sz="1200" dirty="0"/>
              <a:t>: 1.8 </a:t>
            </a:r>
            <a:r>
              <a:rPr lang="en-US" sz="1200" dirty="0" err="1"/>
              <a:t>mo</a:t>
            </a:r>
            <a:endParaRPr lang="en-US" sz="1200" dirty="0"/>
          </a:p>
          <a:p>
            <a:r>
              <a:rPr lang="en-US" sz="1200" dirty="0" err="1"/>
              <a:t>mOS</a:t>
            </a:r>
            <a:r>
              <a:rPr lang="en-US" sz="1200" dirty="0"/>
              <a:t>: 5.2 </a:t>
            </a:r>
            <a:r>
              <a:rPr lang="en-US" sz="1200" dirty="0" err="1"/>
              <a:t>mo</a:t>
            </a:r>
            <a:endParaRPr lang="en-US" sz="1200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C69BA01E-479F-A95A-FB3F-D73F8AFBE1F8}"/>
              </a:ext>
            </a:extLst>
          </p:cNvPr>
          <p:cNvSpPr txBox="1"/>
          <p:nvPr/>
        </p:nvSpPr>
        <p:spPr>
          <a:xfrm>
            <a:off x="10847556" y="4761952"/>
            <a:ext cx="112428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NCT01954745</a:t>
            </a:r>
          </a:p>
          <a:p>
            <a:pPr algn="ctr"/>
            <a:r>
              <a:rPr lang="en-US" sz="1200" dirty="0"/>
              <a:t>[100]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1A670E70-6CA3-A5AB-BD2A-9E45409FBA43}"/>
              </a:ext>
            </a:extLst>
          </p:cNvPr>
          <p:cNvSpPr txBox="1"/>
          <p:nvPr/>
        </p:nvSpPr>
        <p:spPr>
          <a:xfrm>
            <a:off x="2257316" y="4761952"/>
            <a:ext cx="2648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II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2173F215-C452-D56F-C5DD-E2F16CEDBDDC}"/>
              </a:ext>
            </a:extLst>
          </p:cNvPr>
          <p:cNvSpPr txBox="1"/>
          <p:nvPr/>
        </p:nvSpPr>
        <p:spPr>
          <a:xfrm>
            <a:off x="2922702" y="4761952"/>
            <a:ext cx="81424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</a:t>
            </a:r>
            <a:r>
              <a:rPr lang="en-US" sz="1200" baseline="30000" dirty="0"/>
              <a:t>nd</a:t>
            </a:r>
            <a:r>
              <a:rPr lang="en-US" sz="1200" dirty="0"/>
              <a:t> or later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968F7A36-5219-E829-F3FB-CD5B6CD30D3B}"/>
              </a:ext>
            </a:extLst>
          </p:cNvPr>
          <p:cNvSpPr txBox="1"/>
          <p:nvPr/>
        </p:nvSpPr>
        <p:spPr>
          <a:xfrm>
            <a:off x="169600" y="5354696"/>
            <a:ext cx="185002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GemCis+Ramucirumab</a:t>
            </a:r>
            <a:endParaRPr lang="en-US" sz="1200" dirty="0"/>
          </a:p>
          <a:p>
            <a:r>
              <a:rPr lang="en-US" sz="1200" dirty="0" err="1"/>
              <a:t>GemCis+Merestinib</a:t>
            </a:r>
            <a:endParaRPr lang="en-US" sz="1200" dirty="0"/>
          </a:p>
          <a:p>
            <a:r>
              <a:rPr lang="en-US" sz="1200" dirty="0"/>
              <a:t>GemCis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1D6DF2FF-03BA-4C75-A02D-3C5A8FA9A0BB}"/>
              </a:ext>
            </a:extLst>
          </p:cNvPr>
          <p:cNvSpPr txBox="1"/>
          <p:nvPr/>
        </p:nvSpPr>
        <p:spPr>
          <a:xfrm>
            <a:off x="3553925" y="5354696"/>
            <a:ext cx="204744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Unresectable, recurrent, or metastatic CCA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B15CD13B-1C8B-397E-A4BB-27DD2CE53294}"/>
              </a:ext>
            </a:extLst>
          </p:cNvPr>
          <p:cNvSpPr txBox="1"/>
          <p:nvPr/>
        </p:nvSpPr>
        <p:spPr>
          <a:xfrm>
            <a:off x="6140445" y="5354696"/>
            <a:ext cx="1930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mPFS</a:t>
            </a:r>
            <a:r>
              <a:rPr lang="en-US" sz="1200" dirty="0"/>
              <a:t>: 6.5 vs 7.0 vs 6.6 </a:t>
            </a:r>
            <a:r>
              <a:rPr lang="en-US" sz="1200" dirty="0" err="1"/>
              <a:t>mo</a:t>
            </a:r>
            <a:endParaRPr lang="en-US" sz="1200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93000C54-E8FB-5F02-3547-6D357BFF6305}"/>
              </a:ext>
            </a:extLst>
          </p:cNvPr>
          <p:cNvSpPr txBox="1"/>
          <p:nvPr/>
        </p:nvSpPr>
        <p:spPr>
          <a:xfrm>
            <a:off x="10847556" y="5354696"/>
            <a:ext cx="112428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NCT02711553</a:t>
            </a:r>
          </a:p>
          <a:p>
            <a:pPr algn="ctr"/>
            <a:r>
              <a:rPr lang="en-US" sz="1200" dirty="0"/>
              <a:t>[101]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52F3A2CD-A52E-0C35-515D-23162B88BE0F}"/>
              </a:ext>
            </a:extLst>
          </p:cNvPr>
          <p:cNvSpPr txBox="1"/>
          <p:nvPr/>
        </p:nvSpPr>
        <p:spPr>
          <a:xfrm>
            <a:off x="2257316" y="5354696"/>
            <a:ext cx="2648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II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1A9C787D-1230-9B7A-6B99-F07B0B8574B7}"/>
              </a:ext>
            </a:extLst>
          </p:cNvPr>
          <p:cNvSpPr txBox="1"/>
          <p:nvPr/>
        </p:nvSpPr>
        <p:spPr>
          <a:xfrm>
            <a:off x="2922702" y="5354696"/>
            <a:ext cx="81424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</a:t>
            </a:r>
            <a:r>
              <a:rPr lang="en-US" sz="1200" baseline="30000" dirty="0"/>
              <a:t>st</a:t>
            </a:r>
            <a:endParaRPr lang="en-US" sz="1200" dirty="0"/>
          </a:p>
          <a:p>
            <a:endParaRPr lang="en-US" sz="1200" dirty="0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F2D77AA2-416C-614D-EBEF-955435E7D830}"/>
              </a:ext>
            </a:extLst>
          </p:cNvPr>
          <p:cNvSpPr txBox="1"/>
          <p:nvPr/>
        </p:nvSpPr>
        <p:spPr>
          <a:xfrm>
            <a:off x="169600" y="5956184"/>
            <a:ext cx="172620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elumetinib +GemCis GemCis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6B2F2B5A-D48E-7AB2-25E1-6EF14ECF50D8}"/>
              </a:ext>
            </a:extLst>
          </p:cNvPr>
          <p:cNvSpPr txBox="1"/>
          <p:nvPr/>
        </p:nvSpPr>
        <p:spPr>
          <a:xfrm>
            <a:off x="3553925" y="5956184"/>
            <a:ext cx="12433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dvanced CCA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ECDB03AA-1E4E-BEDC-8356-3E83F673A35A}"/>
              </a:ext>
            </a:extLst>
          </p:cNvPr>
          <p:cNvSpPr txBox="1"/>
          <p:nvPr/>
        </p:nvSpPr>
        <p:spPr>
          <a:xfrm>
            <a:off x="6140445" y="5956184"/>
            <a:ext cx="176978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mPFS</a:t>
            </a:r>
            <a:r>
              <a:rPr lang="en-US" sz="1200" dirty="0"/>
              <a:t>: 6.0-7.0 vs 6.3 </a:t>
            </a:r>
            <a:r>
              <a:rPr lang="en-US" sz="1200" dirty="0" err="1"/>
              <a:t>mo</a:t>
            </a:r>
            <a:endParaRPr lang="en-US" sz="1200" dirty="0"/>
          </a:p>
          <a:p>
            <a:r>
              <a:rPr lang="en-US" sz="1200" dirty="0" err="1"/>
              <a:t>mOS</a:t>
            </a:r>
            <a:r>
              <a:rPr lang="en-US" sz="1200" dirty="0"/>
              <a:t>: 11.7 vs 12.8 </a:t>
            </a:r>
            <a:r>
              <a:rPr lang="en-US" sz="1200" dirty="0" err="1"/>
              <a:t>mo</a:t>
            </a:r>
            <a:endParaRPr lang="en-US" sz="1200" dirty="0"/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1E2A4EA7-2B2F-6A0A-9BF1-E6FB35889B02}"/>
              </a:ext>
            </a:extLst>
          </p:cNvPr>
          <p:cNvSpPr txBox="1"/>
          <p:nvPr/>
        </p:nvSpPr>
        <p:spPr>
          <a:xfrm>
            <a:off x="11149850" y="5956184"/>
            <a:ext cx="5196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[116]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0FAB03DE-A1F6-E14D-52D5-1F5B088E4D3D}"/>
              </a:ext>
            </a:extLst>
          </p:cNvPr>
          <p:cNvSpPr txBox="1"/>
          <p:nvPr/>
        </p:nvSpPr>
        <p:spPr>
          <a:xfrm>
            <a:off x="2257316" y="5956184"/>
            <a:ext cx="2648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II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2763825E-0D6E-0814-606F-07A89533FD5F}"/>
              </a:ext>
            </a:extLst>
          </p:cNvPr>
          <p:cNvSpPr txBox="1"/>
          <p:nvPr/>
        </p:nvSpPr>
        <p:spPr>
          <a:xfrm>
            <a:off x="2922702" y="5956184"/>
            <a:ext cx="8142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</a:t>
            </a:r>
            <a:r>
              <a:rPr lang="en-US" sz="1200" baseline="30000" dirty="0"/>
              <a:t>st</a:t>
            </a:r>
            <a:endParaRPr lang="en-US" sz="1200" dirty="0"/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D2D62681-9967-2A7B-E055-F210F7D0D94F}"/>
              </a:ext>
            </a:extLst>
          </p:cNvPr>
          <p:cNvSpPr txBox="1"/>
          <p:nvPr/>
        </p:nvSpPr>
        <p:spPr>
          <a:xfrm>
            <a:off x="169600" y="4188043"/>
            <a:ext cx="22011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orafenib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F8919FC1-6328-BE38-2091-20ED184EC953}"/>
              </a:ext>
            </a:extLst>
          </p:cNvPr>
          <p:cNvSpPr txBox="1"/>
          <p:nvPr/>
        </p:nvSpPr>
        <p:spPr>
          <a:xfrm>
            <a:off x="2922702" y="4188043"/>
            <a:ext cx="7329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</a:t>
            </a:r>
            <a:r>
              <a:rPr lang="en-US" sz="1200" baseline="30000" dirty="0"/>
              <a:t>st</a:t>
            </a:r>
            <a:endParaRPr lang="en-US" sz="1200" dirty="0"/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0E8C98FF-CFDE-69F9-CC30-E18C5DB4FE89}"/>
              </a:ext>
            </a:extLst>
          </p:cNvPr>
          <p:cNvSpPr txBox="1"/>
          <p:nvPr/>
        </p:nvSpPr>
        <p:spPr>
          <a:xfrm>
            <a:off x="3553925" y="4188043"/>
            <a:ext cx="24284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hemotherapy-naïve patients with unresectable or metastatic CCA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C6A1730C-7958-B3C9-DC95-FC0CDC19AAC4}"/>
              </a:ext>
            </a:extLst>
          </p:cNvPr>
          <p:cNvSpPr txBox="1"/>
          <p:nvPr/>
        </p:nvSpPr>
        <p:spPr>
          <a:xfrm>
            <a:off x="6140445" y="4188043"/>
            <a:ext cx="105830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mPFS</a:t>
            </a:r>
            <a:r>
              <a:rPr lang="en-US" sz="1200" dirty="0"/>
              <a:t>: ~3 </a:t>
            </a:r>
            <a:r>
              <a:rPr lang="en-US" sz="1200" dirty="0" err="1"/>
              <a:t>mo</a:t>
            </a:r>
            <a:endParaRPr lang="en-US" sz="1200" dirty="0"/>
          </a:p>
          <a:p>
            <a:r>
              <a:rPr lang="en-US" sz="1200" dirty="0" err="1"/>
              <a:t>mOS</a:t>
            </a:r>
            <a:r>
              <a:rPr lang="en-US" sz="1200" dirty="0"/>
              <a:t>: ~9 </a:t>
            </a:r>
            <a:r>
              <a:rPr lang="en-US" sz="1200" dirty="0" err="1"/>
              <a:t>mo</a:t>
            </a:r>
            <a:endParaRPr lang="en-US" sz="1200" dirty="0"/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F2B79DB7-DD30-B67F-2C5A-E87BDA0BF493}"/>
              </a:ext>
            </a:extLst>
          </p:cNvPr>
          <p:cNvSpPr txBox="1"/>
          <p:nvPr/>
        </p:nvSpPr>
        <p:spPr>
          <a:xfrm>
            <a:off x="11190727" y="4188043"/>
            <a:ext cx="437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[98]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27EF4B3E-EEA7-1122-6978-849D0C93E79F}"/>
              </a:ext>
            </a:extLst>
          </p:cNvPr>
          <p:cNvSpPr txBox="1"/>
          <p:nvPr/>
        </p:nvSpPr>
        <p:spPr>
          <a:xfrm>
            <a:off x="2257316" y="4188043"/>
            <a:ext cx="2648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II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D0493042-4336-1CF1-9DA6-1046DFF2FD25}"/>
              </a:ext>
            </a:extLst>
          </p:cNvPr>
          <p:cNvSpPr txBox="1"/>
          <p:nvPr/>
        </p:nvSpPr>
        <p:spPr>
          <a:xfrm>
            <a:off x="8144226" y="581259"/>
            <a:ext cx="21986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ptos" panose="020B0004020202020204" pitchFamily="34" charset="0"/>
                <a:cs typeface="Times New Roman" panose="02020603050405020304" pitchFamily="18" charset="0"/>
              </a:rPr>
              <a:t>Most common grade </a:t>
            </a:r>
            <a:r>
              <a:rPr lang="en-US" sz="1200" dirty="0">
                <a:latin typeface="Aptos" panose="020B0004020202020204" pitchFamily="34" charset="0"/>
                <a:cs typeface="Times New Roman" panose="02020603050405020304" pitchFamily="18" charset="0"/>
              </a:rPr>
              <a:t>≥ 3</a:t>
            </a:r>
            <a:r>
              <a:rPr lang="en-US" sz="1200" b="1" dirty="0">
                <a:latin typeface="Aptos" panose="020B0004020202020204" pitchFamily="34" charset="0"/>
                <a:cs typeface="Times New Roman" panose="02020603050405020304" pitchFamily="18" charset="0"/>
              </a:rPr>
              <a:t> AEs 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86944D0-6934-21D1-CA7C-9A966106114D}"/>
              </a:ext>
            </a:extLst>
          </p:cNvPr>
          <p:cNvSpPr txBox="1"/>
          <p:nvPr/>
        </p:nvSpPr>
        <p:spPr>
          <a:xfrm>
            <a:off x="8144226" y="816651"/>
            <a:ext cx="196393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Thrombocytopenia ~26.3%</a:t>
            </a:r>
          </a:p>
          <a:p>
            <a:r>
              <a:rPr lang="en-US" sz="1200" dirty="0"/>
              <a:t>Neutropenia ~15.8%</a:t>
            </a:r>
          </a:p>
          <a:p>
            <a:r>
              <a:rPr lang="en-US" sz="1200" dirty="0"/>
              <a:t>Anemia ~10.5%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345C6F3-E3A7-328A-137F-C43C43373BE5}"/>
              </a:ext>
            </a:extLst>
          </p:cNvPr>
          <p:cNvSpPr txBox="1"/>
          <p:nvPr/>
        </p:nvSpPr>
        <p:spPr>
          <a:xfrm>
            <a:off x="8144226" y="1381856"/>
            <a:ext cx="266245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rm A: Cholestasis ~14%, Diarrhea ~9%, Dyspnea ~9%; </a:t>
            </a:r>
          </a:p>
          <a:p>
            <a:r>
              <a:rPr lang="en-US" sz="1200" dirty="0"/>
              <a:t>Arm B: Hepatic toxicity ~20%, Diarrhea ~13%, Nausea ~13%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8A176E7F-ACE9-8808-62B0-99DEFB21B7CC}"/>
              </a:ext>
            </a:extLst>
          </p:cNvPr>
          <p:cNvSpPr txBox="1"/>
          <p:nvPr/>
        </p:nvSpPr>
        <p:spPr>
          <a:xfrm>
            <a:off x="8144226" y="2165856"/>
            <a:ext cx="231412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ommon AEs (not grade-3 specific); nausea and fatigue 78%, diarrhea 67% 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02096852-7148-BDEA-54EE-EA5DFD04C8A5}"/>
              </a:ext>
            </a:extLst>
          </p:cNvPr>
          <p:cNvSpPr txBox="1"/>
          <p:nvPr/>
        </p:nvSpPr>
        <p:spPr>
          <a:xfrm>
            <a:off x="8144226" y="2779262"/>
            <a:ext cx="28087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cross treatment arms: hypertension, increased liver enzymes, diarrhea 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1766797-B124-9ED8-F4C9-C8813F684B01}"/>
              </a:ext>
            </a:extLst>
          </p:cNvPr>
          <p:cNvSpPr txBox="1"/>
          <p:nvPr/>
        </p:nvSpPr>
        <p:spPr>
          <a:xfrm>
            <a:off x="8144226" y="3545029"/>
            <a:ext cx="245984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Neutropenia 36%, fatigue 20%, thrombocytopenia 16%, infections 14%, hand-foot syndrome 10%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0ABE1B18-B149-1F7E-4CC8-E393AEC1AAF6}"/>
              </a:ext>
            </a:extLst>
          </p:cNvPr>
          <p:cNvSpPr txBox="1"/>
          <p:nvPr/>
        </p:nvSpPr>
        <p:spPr>
          <a:xfrm>
            <a:off x="8144227" y="4188043"/>
            <a:ext cx="231412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Hand-foot skin reaction 13%, bilirubin elevation 13%, venous thromboembolism 10%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565732A6-DBFB-9328-054E-E39C2EF34EB4}"/>
              </a:ext>
            </a:extLst>
          </p:cNvPr>
          <p:cNvSpPr txBox="1"/>
          <p:nvPr/>
        </p:nvSpPr>
        <p:spPr>
          <a:xfrm>
            <a:off x="8144226" y="4761952"/>
            <a:ext cx="26062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Neutropenia, hypertension, elevated liver enzymes, hyperbilirubinemia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588FADF9-FCAC-71D3-8305-30A1EBA9900C}"/>
              </a:ext>
            </a:extLst>
          </p:cNvPr>
          <p:cNvSpPr txBox="1"/>
          <p:nvPr/>
        </p:nvSpPr>
        <p:spPr>
          <a:xfrm>
            <a:off x="8144226" y="5354696"/>
            <a:ext cx="249914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Neutropenia 49 vs 47 vs 33%</a:t>
            </a:r>
          </a:p>
          <a:p>
            <a:r>
              <a:rPr lang="en-US" sz="1200" dirty="0"/>
              <a:t>Thrombocytopenia 35 vs 19 vs 17%</a:t>
            </a:r>
          </a:p>
          <a:p>
            <a:r>
              <a:rPr lang="en-US" sz="1200" dirty="0"/>
              <a:t>Anemia 27 vs 16 vs 19%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28F3F1A1-409A-BFE3-2340-5A6EFCC4AF27}"/>
              </a:ext>
            </a:extLst>
          </p:cNvPr>
          <p:cNvSpPr txBox="1"/>
          <p:nvPr/>
        </p:nvSpPr>
        <p:spPr>
          <a:xfrm>
            <a:off x="8144226" y="5956184"/>
            <a:ext cx="245372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elumetinib arm: Neutropenia ~37-40%, thrombocytopenia ~25-30%, anemia ~20%, fatigue ~15%</a:t>
            </a:r>
          </a:p>
        </p:txBody>
      </p:sp>
    </p:spTree>
    <p:extLst>
      <p:ext uri="{BB962C8B-B14F-4D97-AF65-F5344CB8AC3E}">
        <p14:creationId xmlns:p14="http://schemas.microsoft.com/office/powerpoint/2010/main" val="36364202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20BF361-1839-A23F-B751-5FC2BAE58256}"/>
              </a:ext>
            </a:extLst>
          </p:cNvPr>
          <p:cNvSpPr txBox="1"/>
          <p:nvPr/>
        </p:nvSpPr>
        <p:spPr>
          <a:xfrm>
            <a:off x="133031" y="488623"/>
            <a:ext cx="9316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Treatment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5854F7E-A6B3-5F2F-1F70-1E7C6AF396BF}"/>
              </a:ext>
            </a:extLst>
          </p:cNvPr>
          <p:cNvSpPr txBox="1"/>
          <p:nvPr/>
        </p:nvSpPr>
        <p:spPr>
          <a:xfrm>
            <a:off x="3383546" y="488623"/>
            <a:ext cx="762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Patient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DE0EA16-5E5E-EC4B-DFCA-3E7E3EF6F874}"/>
              </a:ext>
            </a:extLst>
          </p:cNvPr>
          <p:cNvSpPr txBox="1"/>
          <p:nvPr/>
        </p:nvSpPr>
        <p:spPr>
          <a:xfrm>
            <a:off x="2778560" y="488623"/>
            <a:ext cx="4796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Lin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4D594A1-58FA-8EA2-0D45-794AB55C0D1D}"/>
              </a:ext>
            </a:extLst>
          </p:cNvPr>
          <p:cNvSpPr txBox="1"/>
          <p:nvPr/>
        </p:nvSpPr>
        <p:spPr>
          <a:xfrm>
            <a:off x="5856452" y="488623"/>
            <a:ext cx="13090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Efficacy Result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404E427-6471-89DA-7E59-37C0893296D8}"/>
              </a:ext>
            </a:extLst>
          </p:cNvPr>
          <p:cNvSpPr txBox="1"/>
          <p:nvPr/>
        </p:nvSpPr>
        <p:spPr>
          <a:xfrm>
            <a:off x="10342767" y="488623"/>
            <a:ext cx="1566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Trial No./Referenc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990DFD5-F068-3AD5-B4D3-52856AAD04AF}"/>
              </a:ext>
            </a:extLst>
          </p:cNvPr>
          <p:cNvSpPr txBox="1"/>
          <p:nvPr/>
        </p:nvSpPr>
        <p:spPr>
          <a:xfrm>
            <a:off x="2205935" y="488623"/>
            <a:ext cx="6174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Phas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5D5123D-B8A2-8238-D785-46C4E8880D45}"/>
              </a:ext>
            </a:extLst>
          </p:cNvPr>
          <p:cNvSpPr txBox="1"/>
          <p:nvPr/>
        </p:nvSpPr>
        <p:spPr>
          <a:xfrm>
            <a:off x="153242" y="37539"/>
            <a:ext cx="1172280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Table S1. Selected Phase II and III clinical trials of targeted therapies showing no clinical efficacy or terminated early, administered as monotherapy or in combination with chemotherapy and/or immunotherapy, in cholangiocarcinoma (CCA) (continued)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99636125-09E0-6520-0AC3-116660B43304}"/>
              </a:ext>
            </a:extLst>
          </p:cNvPr>
          <p:cNvSpPr txBox="1"/>
          <p:nvPr/>
        </p:nvSpPr>
        <p:spPr>
          <a:xfrm>
            <a:off x="133031" y="1322599"/>
            <a:ext cx="22172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tezolizumab+Varlilumab+</a:t>
            </a:r>
          </a:p>
          <a:p>
            <a:r>
              <a:rPr lang="en-US" sz="1200" dirty="0"/>
              <a:t>Cobimetinib (CAV)</a:t>
            </a:r>
          </a:p>
          <a:p>
            <a:r>
              <a:rPr lang="en-US" sz="1200" dirty="0"/>
              <a:t>Atezolizumab+Varlilumab (AV)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D83A2285-83CB-63CF-7E47-DD9ADF132D23}"/>
              </a:ext>
            </a:extLst>
          </p:cNvPr>
          <p:cNvSpPr txBox="1"/>
          <p:nvPr/>
        </p:nvSpPr>
        <p:spPr>
          <a:xfrm>
            <a:off x="3383546" y="1322599"/>
            <a:ext cx="234448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Unresectable CCA, 1–2 prior systemic therapies,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99CF4D18-AEC3-9F0D-A405-7B46EA75DC43}"/>
              </a:ext>
            </a:extLst>
          </p:cNvPr>
          <p:cNvSpPr txBox="1"/>
          <p:nvPr/>
        </p:nvSpPr>
        <p:spPr>
          <a:xfrm>
            <a:off x="10563757" y="1322599"/>
            <a:ext cx="112428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NCT04941287</a:t>
            </a:r>
          </a:p>
          <a:p>
            <a:pPr algn="ctr"/>
            <a:r>
              <a:rPr lang="en-US" sz="1200" dirty="0"/>
              <a:t>[118]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85BA100A-257A-A7F6-7B1C-B457441581D4}"/>
              </a:ext>
            </a:extLst>
          </p:cNvPr>
          <p:cNvSpPr txBox="1"/>
          <p:nvPr/>
        </p:nvSpPr>
        <p:spPr>
          <a:xfrm>
            <a:off x="2205935" y="1322599"/>
            <a:ext cx="2648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II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A72D1598-E4D9-4AAF-D8B1-4904C5FF5004}"/>
              </a:ext>
            </a:extLst>
          </p:cNvPr>
          <p:cNvSpPr txBox="1"/>
          <p:nvPr/>
        </p:nvSpPr>
        <p:spPr>
          <a:xfrm>
            <a:off x="2778560" y="1322599"/>
            <a:ext cx="81424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</a:t>
            </a:r>
            <a:r>
              <a:rPr lang="en-US" sz="1200" baseline="30000" dirty="0"/>
              <a:t>nd </a:t>
            </a:r>
            <a:r>
              <a:rPr lang="en-US" sz="1200" dirty="0"/>
              <a:t>or later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664BC5F3-D0CE-5A9B-7308-60454044206E}"/>
              </a:ext>
            </a:extLst>
          </p:cNvPr>
          <p:cNvSpPr txBox="1"/>
          <p:nvPr/>
        </p:nvSpPr>
        <p:spPr>
          <a:xfrm>
            <a:off x="5856452" y="1322599"/>
            <a:ext cx="151586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ORR: 0% vs 4% </a:t>
            </a:r>
          </a:p>
          <a:p>
            <a:r>
              <a:rPr lang="en-US" sz="1200" dirty="0" err="1"/>
              <a:t>mPFS</a:t>
            </a:r>
            <a:r>
              <a:rPr lang="en-US" sz="1200" dirty="0"/>
              <a:t>: 2.2 vs 1.8 </a:t>
            </a:r>
            <a:r>
              <a:rPr lang="en-US" sz="1200" dirty="0" err="1"/>
              <a:t>mo</a:t>
            </a:r>
            <a:endParaRPr lang="en-US" sz="12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B280D82-FA8F-488C-F24D-0C1438395DD3}"/>
              </a:ext>
            </a:extLst>
          </p:cNvPr>
          <p:cNvSpPr txBox="1"/>
          <p:nvPr/>
        </p:nvSpPr>
        <p:spPr>
          <a:xfrm>
            <a:off x="133031" y="1926313"/>
            <a:ext cx="19992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Everolimus monotherapy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3E509C7-71EE-FB8C-9A4F-F9C8212BC9B4}"/>
              </a:ext>
            </a:extLst>
          </p:cNvPr>
          <p:cNvSpPr txBox="1"/>
          <p:nvPr/>
        </p:nvSpPr>
        <p:spPr>
          <a:xfrm>
            <a:off x="3383546" y="1926313"/>
            <a:ext cx="23356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dvanced CCA, treatment-naïve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0310A5C-6DDD-A087-51FC-4E69DE7F9F22}"/>
              </a:ext>
            </a:extLst>
          </p:cNvPr>
          <p:cNvSpPr txBox="1"/>
          <p:nvPr/>
        </p:nvSpPr>
        <p:spPr>
          <a:xfrm>
            <a:off x="10866051" y="1926313"/>
            <a:ext cx="5196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[121]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450552F-F9E6-D1BC-44C3-777D8889109B}"/>
              </a:ext>
            </a:extLst>
          </p:cNvPr>
          <p:cNvSpPr txBox="1"/>
          <p:nvPr/>
        </p:nvSpPr>
        <p:spPr>
          <a:xfrm>
            <a:off x="2205935" y="1926313"/>
            <a:ext cx="2648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II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FBE1E4D-C9B5-9815-1E96-A0416C0137E1}"/>
              </a:ext>
            </a:extLst>
          </p:cNvPr>
          <p:cNvSpPr txBox="1"/>
          <p:nvPr/>
        </p:nvSpPr>
        <p:spPr>
          <a:xfrm>
            <a:off x="2778560" y="1926313"/>
            <a:ext cx="5612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</a:t>
            </a:r>
            <a:r>
              <a:rPr lang="en-US" sz="1200" baseline="30000" dirty="0"/>
              <a:t>st</a:t>
            </a:r>
            <a:endParaRPr lang="en-US" sz="12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D68290C-3F51-FF4D-597E-6BD644CFB606}"/>
              </a:ext>
            </a:extLst>
          </p:cNvPr>
          <p:cNvSpPr txBox="1"/>
          <p:nvPr/>
        </p:nvSpPr>
        <p:spPr>
          <a:xfrm>
            <a:off x="5856452" y="1926313"/>
            <a:ext cx="151195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ORR: 5%, DCR: 45%</a:t>
            </a:r>
          </a:p>
          <a:p>
            <a:r>
              <a:rPr lang="en-US" sz="1200" dirty="0"/>
              <a:t>mPFS: 5.5 </a:t>
            </a:r>
            <a:r>
              <a:rPr lang="en-US" sz="1200" dirty="0" err="1"/>
              <a:t>mo</a:t>
            </a:r>
            <a:endParaRPr lang="en-US" sz="1200" dirty="0"/>
          </a:p>
          <a:p>
            <a:r>
              <a:rPr lang="en-US" sz="1200" dirty="0"/>
              <a:t>mOS: 9.5 </a:t>
            </a:r>
            <a:r>
              <a:rPr lang="en-US" sz="1200" dirty="0" err="1"/>
              <a:t>mo</a:t>
            </a:r>
            <a:endParaRPr lang="en-US" sz="12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3A6E88A-028F-EFEF-DFBF-C37479F45A0D}"/>
              </a:ext>
            </a:extLst>
          </p:cNvPr>
          <p:cNvSpPr txBox="1"/>
          <p:nvPr/>
        </p:nvSpPr>
        <p:spPr>
          <a:xfrm>
            <a:off x="133031" y="2535505"/>
            <a:ext cx="199928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MK-2206 monotherapy</a:t>
            </a:r>
          </a:p>
          <a:p>
            <a:r>
              <a:rPr lang="en-US" sz="1200" dirty="0"/>
              <a:t>(oral pan-AKT inhibitor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CCA534B-86D0-E81D-5460-563F39EA6A95}"/>
              </a:ext>
            </a:extLst>
          </p:cNvPr>
          <p:cNvSpPr txBox="1"/>
          <p:nvPr/>
        </p:nvSpPr>
        <p:spPr>
          <a:xfrm>
            <a:off x="3383546" y="2535505"/>
            <a:ext cx="233564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dvanced unresectable or metastatic CCA who progressed after ≥1 line of chemotherapy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468BC03-4FCF-B0BE-C63A-78498B50A628}"/>
              </a:ext>
            </a:extLst>
          </p:cNvPr>
          <p:cNvSpPr txBox="1"/>
          <p:nvPr/>
        </p:nvSpPr>
        <p:spPr>
          <a:xfrm>
            <a:off x="10563757" y="2535505"/>
            <a:ext cx="112428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NCT01425879</a:t>
            </a:r>
          </a:p>
          <a:p>
            <a:pPr algn="ctr"/>
            <a:r>
              <a:rPr lang="en-US" sz="1200" dirty="0"/>
              <a:t>[123]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F371DBB-F90C-2DCA-BD9B-5EE066EF2492}"/>
              </a:ext>
            </a:extLst>
          </p:cNvPr>
          <p:cNvSpPr txBox="1"/>
          <p:nvPr/>
        </p:nvSpPr>
        <p:spPr>
          <a:xfrm>
            <a:off x="2205935" y="2535505"/>
            <a:ext cx="2648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II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68C23EF-C320-275E-E86E-D938606DA61A}"/>
              </a:ext>
            </a:extLst>
          </p:cNvPr>
          <p:cNvSpPr txBox="1"/>
          <p:nvPr/>
        </p:nvSpPr>
        <p:spPr>
          <a:xfrm>
            <a:off x="2778560" y="2535505"/>
            <a:ext cx="5612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</a:t>
            </a:r>
            <a:r>
              <a:rPr lang="en-US" sz="1200" baseline="30000" dirty="0"/>
              <a:t>nd</a:t>
            </a:r>
            <a:endParaRPr lang="en-US" sz="12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3903337-6AC0-C798-7E51-7B87E6B7B994}"/>
              </a:ext>
            </a:extLst>
          </p:cNvPr>
          <p:cNvSpPr txBox="1"/>
          <p:nvPr/>
        </p:nvSpPr>
        <p:spPr>
          <a:xfrm>
            <a:off x="5856452" y="2535505"/>
            <a:ext cx="139974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ORR: 0%, SD: 44%</a:t>
            </a:r>
          </a:p>
          <a:p>
            <a:r>
              <a:rPr lang="en-US" sz="1200" dirty="0" err="1"/>
              <a:t>mPFS</a:t>
            </a:r>
            <a:r>
              <a:rPr lang="en-US" sz="1200" dirty="0"/>
              <a:t>: 1.7 </a:t>
            </a:r>
            <a:r>
              <a:rPr lang="en-US" sz="1200" dirty="0" err="1"/>
              <a:t>mo</a:t>
            </a:r>
            <a:endParaRPr lang="en-US" sz="1200" dirty="0"/>
          </a:p>
          <a:p>
            <a:r>
              <a:rPr lang="en-US" sz="1200" dirty="0" err="1"/>
              <a:t>mOS</a:t>
            </a:r>
            <a:r>
              <a:rPr lang="en-US" sz="1200" dirty="0"/>
              <a:t>: 3.5 </a:t>
            </a:r>
            <a:r>
              <a:rPr lang="en-US" sz="1200" dirty="0" err="1"/>
              <a:t>mo</a:t>
            </a:r>
            <a:endParaRPr lang="en-US" sz="12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533F27CD-C1A5-AC84-9FBC-D63922CBF1FC}"/>
              </a:ext>
            </a:extLst>
          </p:cNvPr>
          <p:cNvSpPr txBox="1"/>
          <p:nvPr/>
        </p:nvSpPr>
        <p:spPr>
          <a:xfrm>
            <a:off x="133031" y="3154452"/>
            <a:ext cx="199928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Olaparib (PARP inhibitor)</a:t>
            </a:r>
          </a:p>
          <a:p>
            <a:r>
              <a:rPr lang="en-US" sz="1200" dirty="0"/>
              <a:t>+ Durvalumab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9B260167-6745-8D7A-6E52-EF790A6742A8}"/>
              </a:ext>
            </a:extLst>
          </p:cNvPr>
          <p:cNvSpPr txBox="1"/>
          <p:nvPr/>
        </p:nvSpPr>
        <p:spPr>
          <a:xfrm>
            <a:off x="3383546" y="3154452"/>
            <a:ext cx="258274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dvanced CCA harboring IDH mutations, received no more than two prior lines of systemic therapy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B4CDF9C5-FF50-E13E-AB6B-D5A8C2220447}"/>
              </a:ext>
            </a:extLst>
          </p:cNvPr>
          <p:cNvSpPr txBox="1"/>
          <p:nvPr/>
        </p:nvSpPr>
        <p:spPr>
          <a:xfrm>
            <a:off x="10563757" y="3154452"/>
            <a:ext cx="112428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NCT03991832</a:t>
            </a:r>
          </a:p>
          <a:p>
            <a:pPr algn="ctr"/>
            <a:r>
              <a:rPr lang="en-US" sz="1200" dirty="0"/>
              <a:t>[134]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E99B1F15-BF33-44CD-9DA2-C5AB0FEF3821}"/>
              </a:ext>
            </a:extLst>
          </p:cNvPr>
          <p:cNvSpPr txBox="1"/>
          <p:nvPr/>
        </p:nvSpPr>
        <p:spPr>
          <a:xfrm>
            <a:off x="2205935" y="3154452"/>
            <a:ext cx="2648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II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BACE554C-39BE-839C-8B18-DB57F5935F5F}"/>
              </a:ext>
            </a:extLst>
          </p:cNvPr>
          <p:cNvSpPr txBox="1"/>
          <p:nvPr/>
        </p:nvSpPr>
        <p:spPr>
          <a:xfrm>
            <a:off x="2778560" y="3154452"/>
            <a:ext cx="56120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</a:t>
            </a:r>
            <a:r>
              <a:rPr lang="en-US" sz="1200" baseline="30000" dirty="0"/>
              <a:t>nd </a:t>
            </a:r>
            <a:r>
              <a:rPr lang="en-US" sz="1200" dirty="0"/>
              <a:t>or later 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5FF65106-0AE8-14BC-B807-92739561AADA}"/>
              </a:ext>
            </a:extLst>
          </p:cNvPr>
          <p:cNvSpPr txBox="1"/>
          <p:nvPr/>
        </p:nvSpPr>
        <p:spPr>
          <a:xfrm>
            <a:off x="5856452" y="3154452"/>
            <a:ext cx="118333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R or PR: 0</a:t>
            </a:r>
          </a:p>
          <a:p>
            <a:r>
              <a:rPr lang="en-US" sz="1200" dirty="0" err="1"/>
              <a:t>mPFS</a:t>
            </a:r>
            <a:r>
              <a:rPr lang="en-US" sz="1200" dirty="0"/>
              <a:t>: 1.97 </a:t>
            </a:r>
            <a:r>
              <a:rPr lang="en-US" sz="1200" dirty="0" err="1"/>
              <a:t>mo</a:t>
            </a:r>
            <a:endParaRPr lang="en-US" sz="1200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3C8DF2A5-B845-B382-F828-0A60A7C38425}"/>
              </a:ext>
            </a:extLst>
          </p:cNvPr>
          <p:cNvSpPr txBox="1"/>
          <p:nvPr/>
        </p:nvSpPr>
        <p:spPr>
          <a:xfrm>
            <a:off x="133031" y="720775"/>
            <a:ext cx="16554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Trametinib</a:t>
            </a:r>
          </a:p>
          <a:p>
            <a:r>
              <a:rPr lang="en-US" sz="1200" dirty="0"/>
              <a:t>Chemotherapy (5-FU or capecitabine)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5B06B667-7C94-720B-C2FD-A8A871B9A048}"/>
              </a:ext>
            </a:extLst>
          </p:cNvPr>
          <p:cNvSpPr txBox="1"/>
          <p:nvPr/>
        </p:nvSpPr>
        <p:spPr>
          <a:xfrm>
            <a:off x="3383546" y="720775"/>
            <a:ext cx="191617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dvanced CCA, progressive disease after 1 prior systemic therapy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A20FCCB6-0069-B350-8719-EBF225A19FB2}"/>
              </a:ext>
            </a:extLst>
          </p:cNvPr>
          <p:cNvSpPr txBox="1"/>
          <p:nvPr/>
        </p:nvSpPr>
        <p:spPr>
          <a:xfrm>
            <a:off x="5856452" y="720775"/>
            <a:ext cx="151586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ORR: 0 vs 5%</a:t>
            </a:r>
          </a:p>
          <a:p>
            <a:r>
              <a:rPr lang="en-US" sz="1200" dirty="0" err="1"/>
              <a:t>mPFS</a:t>
            </a:r>
            <a:r>
              <a:rPr lang="en-US" sz="1200" dirty="0"/>
              <a:t>: 1.5 vs 3.3 </a:t>
            </a:r>
            <a:r>
              <a:rPr lang="en-US" sz="1200" dirty="0" err="1"/>
              <a:t>mo</a:t>
            </a:r>
            <a:endParaRPr lang="en-US" sz="1200" dirty="0"/>
          </a:p>
          <a:p>
            <a:r>
              <a:rPr lang="en-US" sz="1200" dirty="0" err="1"/>
              <a:t>mOS</a:t>
            </a:r>
            <a:r>
              <a:rPr lang="en-US" sz="1200" dirty="0"/>
              <a:t>: 4.3 vs 6.6 </a:t>
            </a:r>
            <a:r>
              <a:rPr lang="en-US" sz="1200" dirty="0" err="1"/>
              <a:t>mo</a:t>
            </a:r>
            <a:endParaRPr lang="en-US" sz="1200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1F4D1203-88AD-4B35-4346-90B408CEA838}"/>
              </a:ext>
            </a:extLst>
          </p:cNvPr>
          <p:cNvSpPr txBox="1"/>
          <p:nvPr/>
        </p:nvSpPr>
        <p:spPr>
          <a:xfrm>
            <a:off x="10866051" y="720775"/>
            <a:ext cx="5196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/>
              <a:t>[117]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3ED12460-8BD9-4A00-F130-FA6768F6E45A}"/>
              </a:ext>
            </a:extLst>
          </p:cNvPr>
          <p:cNvSpPr txBox="1"/>
          <p:nvPr/>
        </p:nvSpPr>
        <p:spPr>
          <a:xfrm>
            <a:off x="2205935" y="720775"/>
            <a:ext cx="2648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II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3613CF9A-84A7-E193-D98D-546788A4238D}"/>
              </a:ext>
            </a:extLst>
          </p:cNvPr>
          <p:cNvSpPr txBox="1"/>
          <p:nvPr/>
        </p:nvSpPr>
        <p:spPr>
          <a:xfrm>
            <a:off x="2778560" y="720775"/>
            <a:ext cx="81424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2</a:t>
            </a:r>
            <a:r>
              <a:rPr lang="en-US" sz="1200" baseline="30000" dirty="0"/>
              <a:t>nd </a:t>
            </a:r>
            <a:r>
              <a:rPr lang="en-US" sz="1200" dirty="0"/>
              <a:t>or later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FD70A25-E984-7329-D36C-E7AE591DE394}"/>
              </a:ext>
            </a:extLst>
          </p:cNvPr>
          <p:cNvSpPr txBox="1"/>
          <p:nvPr/>
        </p:nvSpPr>
        <p:spPr>
          <a:xfrm>
            <a:off x="7563941" y="510568"/>
            <a:ext cx="21986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ptos" panose="020B0004020202020204" pitchFamily="34" charset="0"/>
                <a:cs typeface="Times New Roman" panose="02020603050405020304" pitchFamily="18" charset="0"/>
              </a:rPr>
              <a:t>Most common grade </a:t>
            </a:r>
            <a:r>
              <a:rPr lang="en-US" sz="1200" dirty="0">
                <a:latin typeface="Aptos" panose="020B0004020202020204" pitchFamily="34" charset="0"/>
                <a:cs typeface="Times New Roman" panose="02020603050405020304" pitchFamily="18" charset="0"/>
              </a:rPr>
              <a:t>≥ 3</a:t>
            </a:r>
            <a:r>
              <a:rPr lang="en-US" sz="1200" b="1" dirty="0">
                <a:latin typeface="Aptos" panose="020B0004020202020204" pitchFamily="34" charset="0"/>
                <a:cs typeface="Times New Roman" panose="02020603050405020304" pitchFamily="18" charset="0"/>
              </a:rPr>
              <a:t> AEs 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9813C5F-EF94-5A12-96AB-A92E77C491FE}"/>
              </a:ext>
            </a:extLst>
          </p:cNvPr>
          <p:cNvSpPr txBox="1"/>
          <p:nvPr/>
        </p:nvSpPr>
        <p:spPr>
          <a:xfrm>
            <a:off x="7563941" y="720775"/>
            <a:ext cx="10313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Not reported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5CADE2A-EB3B-9892-4DB0-63EE9DCD0C4F}"/>
              </a:ext>
            </a:extLst>
          </p:cNvPr>
          <p:cNvSpPr txBox="1"/>
          <p:nvPr/>
        </p:nvSpPr>
        <p:spPr>
          <a:xfrm>
            <a:off x="7563941" y="1322599"/>
            <a:ext cx="281445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AV: rash, diarrhea, nausea/vomiting, thrombocytopenia; AV: immune-related toxicities, diarrhea, nausea/vomiting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6A773A8-36E0-E5BB-B37B-195379DA8EF4}"/>
              </a:ext>
            </a:extLst>
          </p:cNvPr>
          <p:cNvSpPr txBox="1"/>
          <p:nvPr/>
        </p:nvSpPr>
        <p:spPr>
          <a:xfrm>
            <a:off x="7563941" y="1926313"/>
            <a:ext cx="10313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Not reported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550672B-AB93-F244-8191-EACB0FD84F27}"/>
              </a:ext>
            </a:extLst>
          </p:cNvPr>
          <p:cNvSpPr txBox="1"/>
          <p:nvPr/>
        </p:nvSpPr>
        <p:spPr>
          <a:xfrm>
            <a:off x="7563941" y="2535505"/>
            <a:ext cx="137114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Diarrhea 12.5%</a:t>
            </a:r>
          </a:p>
          <a:p>
            <a:r>
              <a:rPr lang="en-US" sz="1200" dirty="0"/>
              <a:t>Macular rash 38%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702C701-815E-790E-AB72-7DE690EF3B18}"/>
              </a:ext>
            </a:extLst>
          </p:cNvPr>
          <p:cNvSpPr txBox="1"/>
          <p:nvPr/>
        </p:nvSpPr>
        <p:spPr>
          <a:xfrm>
            <a:off x="7563941" y="3154452"/>
            <a:ext cx="23869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nemia 8%, Abdominal pain 6%, elevated amylase or lipase 6%, pancreatitis 4%</a:t>
            </a:r>
          </a:p>
        </p:txBody>
      </p:sp>
    </p:spTree>
    <p:extLst>
      <p:ext uri="{BB962C8B-B14F-4D97-AF65-F5344CB8AC3E}">
        <p14:creationId xmlns:p14="http://schemas.microsoft.com/office/powerpoint/2010/main" val="7171653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57</TotalTime>
  <Words>801</Words>
  <Application>Microsoft Office PowerPoint</Application>
  <PresentationFormat>Widescreen</PresentationFormat>
  <Paragraphs>166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wasthi, Niranjan</dc:creator>
  <cp:lastModifiedBy>MDPI</cp:lastModifiedBy>
  <cp:revision>49</cp:revision>
  <dcterms:created xsi:type="dcterms:W3CDTF">2025-08-13T19:19:02Z</dcterms:created>
  <dcterms:modified xsi:type="dcterms:W3CDTF">2025-11-05T05:35:24Z</dcterms:modified>
</cp:coreProperties>
</file>